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10080625" cy="7559675"/>
  <p:notesSz cx="7559675" cy="106918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1" userDrawn="1">
          <p15:clr>
            <a:srgbClr val="A4A3A4"/>
          </p15:clr>
        </p15:guide>
        <p15:guide id="2" pos="317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">
    <a:wholeTbl>
      <a:tcTxStyle>
        <a:font>
          <a:latin typeface="+mn-lt"/>
          <a:ea typeface="+mn-ea"/>
          <a:cs typeface="+mn-cs"/>
        </a:font>
        <a:srgbClr val="000000"/>
      </a:tcTxStyle>
      <a:tcStyle>
        <a:tcBdr>
          <a:left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left>
          <a:right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right>
          <a:top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top>
          <a:bottom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bottom>
        </a:tcBdr>
        <a:fill>
          <a:solidFill>
            <a:srgbClr val="EAEFF7"/>
          </a:solidFill>
        </a:fill>
      </a:tcStyle>
    </a:wholeTbl>
    <a:band1H>
      <a:tcStyle>
        <a:tcBdr/>
        <a:fill>
          <a:solidFill>
            <a:srgbClr val="D2DEEF"/>
          </a:solidFill>
        </a:fill>
      </a:tcStyle>
    </a:band1H>
    <a:band2H>
      <a:tcStyle>
        <a:tcBdr/>
      </a:tcStyle>
    </a:band2H>
    <a:band1V>
      <a:tcStyle>
        <a:tcBdr/>
        <a:fill>
          <a:solidFill>
            <a:srgbClr val="D2DEEF"/>
          </a:solidFill>
        </a:fill>
      </a:tcStyle>
    </a:band1V>
    <a:band2V>
      <a:tcStyle>
        <a:tcBdr/>
      </a:tcStyle>
    </a:band2V>
    <a:lastCol>
      <a:tcTxStyle b="on">
        <a:font>
          <a:latin typeface="+mn-lt"/>
          <a:ea typeface="+mn-ea"/>
          <a:cs typeface="+mn-cs"/>
        </a:font>
        <a:srgbClr val="FFFFFF"/>
      </a:tcTxStyle>
      <a:tcStyle>
        <a:tcBdr/>
        <a:fill>
          <a:solidFill>
            <a:srgbClr val="5B9BD5"/>
          </a:solidFill>
        </a:fill>
      </a:tcStyle>
    </a:lastCol>
    <a:firstCol>
      <a:tcTxStyle b="on">
        <a:font>
          <a:latin typeface="+mn-lt"/>
          <a:ea typeface="+mn-ea"/>
          <a:cs typeface="+mn-cs"/>
        </a:font>
        <a:srgbClr val="FFFFFF"/>
      </a:tcTxStyle>
      <a:tcStyle>
        <a:tcBdr/>
        <a:fill>
          <a:solidFill>
            <a:srgbClr val="5B9BD5"/>
          </a:solidFill>
        </a:fill>
      </a:tcStyle>
    </a:firstCol>
    <a:lastRow>
      <a:tcTxStyle b="on">
        <a:font>
          <a:latin typeface="+mn-lt"/>
          <a:ea typeface="+mn-ea"/>
          <a:cs typeface="+mn-cs"/>
        </a:font>
        <a:srgbClr val="FFFFFF"/>
      </a:tcTxStyle>
      <a:tcStyle>
        <a:tcBdr>
          <a:top>
            <a:ln w="38103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top>
        </a:tcBdr>
        <a:fill>
          <a:solidFill>
            <a:srgbClr val="5B9BD5"/>
          </a:solidFill>
        </a:fill>
      </a:tcStyle>
    </a:lastRow>
    <a:firstRow>
      <a:tcTxStyle b="on">
        <a:font>
          <a:latin typeface="+mn-lt"/>
          <a:ea typeface="+mn-ea"/>
          <a:cs typeface="+mn-cs"/>
        </a:font>
        <a:srgbClr val="FFFFFF"/>
      </a:tcTxStyle>
      <a:tcStyle>
        <a:tcBdr>
          <a:bottom>
            <a:ln w="38103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bottom>
        </a:tcBdr>
        <a:fill>
          <a:solidFill>
            <a:srgbClr val="5B9BD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90" d="100"/>
          <a:sy n="90" d="100"/>
        </p:scale>
        <p:origin x="252" y="96"/>
      </p:cViewPr>
      <p:guideLst>
        <p:guide orient="horz" pos="2381"/>
        <p:guide pos="31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280684" cy="534238"/>
          </a:xfrm>
          <a:prstGeom prst="rect">
            <a:avLst/>
          </a:prstGeom>
          <a:noFill/>
          <a:ln>
            <a:noFill/>
          </a:ln>
        </p:spPr>
        <p:txBody>
          <a:bodyPr vert="horz" wrap="square" lIns="90004" tIns="44997" rIns="90004" bIns="44997" anchor="t" anchorCtr="0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4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3" name="Marcador de fecha 2"/>
          <p:cNvSpPr txBox="1">
            <a:spLocks noGrp="1"/>
          </p:cNvSpPr>
          <p:nvPr>
            <p:ph type="dt" sz="quarter" idx="1"/>
          </p:nvPr>
        </p:nvSpPr>
        <p:spPr>
          <a:xfrm>
            <a:off x="4278962" y="0"/>
            <a:ext cx="3280684" cy="534238"/>
          </a:xfrm>
          <a:prstGeom prst="rect">
            <a:avLst/>
          </a:prstGeom>
          <a:noFill/>
          <a:ln>
            <a:noFill/>
          </a:ln>
        </p:spPr>
        <p:txBody>
          <a:bodyPr vert="horz" wrap="square" lIns="90004" tIns="44997" rIns="90004" bIns="44997" anchor="t" anchorCtr="0" compatLnSpc="0">
            <a:noAutofit/>
          </a:bodyPr>
          <a:lstStyle/>
          <a:p>
            <a:pPr marL="0" marR="0" lvl="0" indent="0" algn="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4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4" name="Marcador de pie de página 3"/>
          <p:cNvSpPr txBox="1">
            <a:spLocks noGrp="1"/>
          </p:cNvSpPr>
          <p:nvPr>
            <p:ph type="ftr" sz="quarter" idx="2"/>
          </p:nvPr>
        </p:nvSpPr>
        <p:spPr>
          <a:xfrm>
            <a:off x="0" y="10157402"/>
            <a:ext cx="3280684" cy="534238"/>
          </a:xfrm>
          <a:prstGeom prst="rect">
            <a:avLst/>
          </a:prstGeom>
          <a:noFill/>
          <a:ln>
            <a:noFill/>
          </a:ln>
        </p:spPr>
        <p:txBody>
          <a:bodyPr vert="horz" wrap="square" lIns="90004" tIns="44997" rIns="90004" bIns="44997" anchor="b" anchorCtr="0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4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5" name="Marcador de número de diapositiva 4"/>
          <p:cNvSpPr txBox="1">
            <a:spLocks noGrp="1"/>
          </p:cNvSpPr>
          <p:nvPr>
            <p:ph type="sldNum" sz="quarter" idx="3"/>
          </p:nvPr>
        </p:nvSpPr>
        <p:spPr>
          <a:xfrm>
            <a:off x="4278962" y="10157402"/>
            <a:ext cx="3280684" cy="534238"/>
          </a:xfrm>
          <a:prstGeom prst="rect">
            <a:avLst/>
          </a:prstGeom>
          <a:noFill/>
          <a:ln>
            <a:noFill/>
          </a:ln>
        </p:spPr>
        <p:txBody>
          <a:bodyPr vert="horz" wrap="square" lIns="90004" tIns="44997" rIns="90004" bIns="44997" anchor="b" anchorCtr="0" compatLnSpc="0">
            <a:noAutofit/>
          </a:bodyPr>
          <a:lstStyle/>
          <a:p>
            <a:pPr marL="0" marR="0" lvl="0" indent="0" algn="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fld id="{EB57094E-6197-4622-94B0-5A3E33A0EB3D}" type="slidenum">
              <a:t>‹Nº›</a:t>
            </a:fld>
            <a:endParaRPr lang="es-ES" sz="14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</p:spTree>
    <p:extLst>
      <p:ext uri="{BB962C8B-B14F-4D97-AF65-F5344CB8AC3E}">
        <p14:creationId xmlns:p14="http://schemas.microsoft.com/office/powerpoint/2010/main" val="105968557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 idx="2"/>
          </p:nvPr>
        </p:nvSpPr>
        <p:spPr>
          <a:xfrm>
            <a:off x="1107000" y="812517"/>
            <a:ext cx="5345280" cy="4008958"/>
          </a:xfrm>
          <a:prstGeom prst="rect">
            <a:avLst/>
          </a:prstGeom>
          <a:noFill/>
          <a:ln>
            <a:noFill/>
            <a:prstDash val="solid"/>
          </a:ln>
        </p:spPr>
      </p:sp>
      <p:sp>
        <p:nvSpPr>
          <p:cNvPr id="3" name="Marcador de notas 2"/>
          <p:cNvSpPr txBox="1">
            <a:spLocks noGrp="1"/>
          </p:cNvSpPr>
          <p:nvPr>
            <p:ph type="body" sz="quarter" idx="3"/>
          </p:nvPr>
        </p:nvSpPr>
        <p:spPr>
          <a:xfrm>
            <a:off x="755998" y="5078522"/>
            <a:ext cx="6047640" cy="4811042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t" anchorCtr="0" compatLnSpc="1">
            <a:noAutofit/>
          </a:bodyPr>
          <a:lstStyle/>
          <a:p>
            <a:pPr lvl="0"/>
            <a:endParaRPr lang="es-ES"/>
          </a:p>
        </p:txBody>
      </p:sp>
      <p:sp>
        <p:nvSpPr>
          <p:cNvPr id="4" name="Marcador de encabezado 3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280684" cy="534238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t" anchorCtr="0" compatLnSpc="1">
            <a:noAutofit/>
          </a:bodyPr>
          <a:lstStyle>
            <a:lvl1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s-ES" sz="14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endParaRPr lang="es-ES"/>
          </a:p>
        </p:txBody>
      </p:sp>
      <p:sp>
        <p:nvSpPr>
          <p:cNvPr id="5" name="Marcador de fecha 4"/>
          <p:cNvSpPr txBox="1">
            <a:spLocks noGrp="1"/>
          </p:cNvSpPr>
          <p:nvPr>
            <p:ph type="dt" idx="1"/>
          </p:nvPr>
        </p:nvSpPr>
        <p:spPr>
          <a:xfrm>
            <a:off x="4278962" y="0"/>
            <a:ext cx="3280684" cy="534238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t" anchorCtr="0" compatLnSpc="1">
            <a:noAutofit/>
          </a:bodyPr>
          <a:lstStyle>
            <a:lvl1pPr marL="0" marR="0" lvl="0" indent="0" algn="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s-ES" sz="14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endParaRPr lang="es-ES"/>
          </a:p>
        </p:txBody>
      </p:sp>
      <p:sp>
        <p:nvSpPr>
          <p:cNvPr id="6" name="Marcador de pie de página 5"/>
          <p:cNvSpPr txBox="1">
            <a:spLocks noGrp="1"/>
          </p:cNvSpPr>
          <p:nvPr>
            <p:ph type="ftr" sz="quarter" idx="4"/>
          </p:nvPr>
        </p:nvSpPr>
        <p:spPr>
          <a:xfrm>
            <a:off x="0" y="10157402"/>
            <a:ext cx="3280684" cy="534238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b" anchorCtr="0" compatLnSpc="1">
            <a:noAutofit/>
          </a:bodyPr>
          <a:lstStyle>
            <a:lvl1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s-ES" sz="14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endParaRPr lang="es-ES"/>
          </a:p>
        </p:txBody>
      </p:sp>
      <p:sp>
        <p:nvSpPr>
          <p:cNvPr id="7" name="Marcador de número de diapositiva 6"/>
          <p:cNvSpPr txBox="1">
            <a:spLocks noGrp="1"/>
          </p:cNvSpPr>
          <p:nvPr>
            <p:ph type="sldNum" sz="quarter" idx="5"/>
          </p:nvPr>
        </p:nvSpPr>
        <p:spPr>
          <a:xfrm>
            <a:off x="4278962" y="10157402"/>
            <a:ext cx="3280684" cy="534238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b" anchorCtr="0" compatLnSpc="1">
            <a:noAutofit/>
          </a:bodyPr>
          <a:lstStyle>
            <a:lvl1pPr marL="0" marR="0" lvl="0" indent="0" algn="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s-ES" sz="14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fld id="{1D1D7BC5-30EE-4C86-BDF2-54ED342180DA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30096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215999" marR="0" lvl="0" indent="-215999" defTabSz="914400" rtl="0" fontAlgn="auto" hangingPunct="0">
      <a:lnSpc>
        <a:spcPct val="100000"/>
      </a:lnSpc>
      <a:spcBef>
        <a:spcPts val="0"/>
      </a:spcBef>
      <a:spcAft>
        <a:spcPts val="0"/>
      </a:spcAft>
      <a:buNone/>
      <a:tabLst/>
      <a:defRPr lang="es-ES" sz="2000" b="0" i="0" u="none" strike="noStrike" kern="1200" cap="none" spc="0" baseline="0">
        <a:solidFill>
          <a:srgbClr val="000000"/>
        </a:solidFill>
        <a:uFillTx/>
        <a:latin typeface="Arial" pitchFamily="18"/>
        <a:ea typeface="Microsoft YaHei" pitchFamily="2"/>
        <a:cs typeface="Mangal" pitchFamily="2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número de diapositiva 6"/>
          <p:cNvSpPr txBox="1"/>
          <p:nvPr/>
        </p:nvSpPr>
        <p:spPr>
          <a:xfrm>
            <a:off x="4278962" y="10157402"/>
            <a:ext cx="3280684" cy="534238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0" tIns="0" rIns="0" bIns="0" anchor="b" anchorCtr="0" compatLnSpc="1">
            <a:noAutofit/>
          </a:bodyPr>
          <a:lstStyle/>
          <a:p>
            <a:pPr marL="0" marR="0" lvl="0" indent="0" algn="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fld id="{847CA2D7-A428-4C29-BC67-C857EB5002AD}" type="slidenum">
              <a:t>1</a:t>
            </a:fld>
            <a:endParaRPr lang="es-ES" sz="1400" b="0" i="0" u="none" strike="noStrike" kern="1200" cap="none" spc="0" baseline="0">
              <a:solidFill>
                <a:srgbClr val="000000"/>
              </a:solidFill>
              <a:uFillTx/>
              <a:latin typeface="Times New Roman" pitchFamily="18"/>
              <a:ea typeface="Lucida Sans Unicode" pitchFamily="2"/>
              <a:cs typeface="Tahoma" pitchFamily="2"/>
            </a:endParaRPr>
          </a:p>
        </p:txBody>
      </p:sp>
      <p:sp>
        <p:nvSpPr>
          <p:cNvPr id="3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106488" y="812800"/>
            <a:ext cx="5345112" cy="4008438"/>
          </a:xfrm>
          <a:solidFill>
            <a:srgbClr val="5B9BD5"/>
          </a:solidFill>
          <a:ln w="25402">
            <a:solidFill>
              <a:srgbClr val="41719C"/>
            </a:solidFill>
            <a:prstDash val="solid"/>
          </a:ln>
        </p:spPr>
      </p:sp>
      <p:sp>
        <p:nvSpPr>
          <p:cNvPr id="4" name="Marcador de notas 2"/>
          <p:cNvSpPr txBox="1">
            <a:spLocks noGrp="1"/>
          </p:cNvSpPr>
          <p:nvPr>
            <p:ph type="body" sz="quarter" idx="1"/>
          </p:nvPr>
        </p:nvSpPr>
        <p:spPr/>
        <p:txBody>
          <a:bodyPr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71316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 txBox="1">
            <a:spLocks noGrp="1"/>
          </p:cNvSpPr>
          <p:nvPr>
            <p:ph type="ctrTitle"/>
          </p:nvPr>
        </p:nvSpPr>
        <p:spPr>
          <a:xfrm>
            <a:off x="1260472" y="1236661"/>
            <a:ext cx="7559673" cy="2632072"/>
          </a:xfrm>
        </p:spPr>
        <p:txBody>
          <a:bodyPr anchor="b"/>
          <a:lstStyle>
            <a:lvl1pPr>
              <a:defRPr sz="6000"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 txBox="1">
            <a:spLocks noGrp="1"/>
          </p:cNvSpPr>
          <p:nvPr>
            <p:ph type="subTitle" idx="1"/>
          </p:nvPr>
        </p:nvSpPr>
        <p:spPr>
          <a:xfrm>
            <a:off x="1260472" y="3970333"/>
            <a:ext cx="7559673" cy="1825627"/>
          </a:xfrm>
        </p:spPr>
        <p:txBody>
          <a:bodyPr anchorCtr="1"/>
          <a:lstStyle>
            <a:lvl1pPr algn="ctr">
              <a:defRPr sz="2400"/>
            </a:lvl1pPr>
          </a:lstStyle>
          <a:p>
            <a:pPr lvl="0"/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5" name="Marcador de pie de página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1A34FEE6-BE2F-48EA-AB68-EC79D44092FB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882579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5" name="Marcador de pie de página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161A977-6730-4374-83DE-5BEB103CD73D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46962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 txBox="1">
            <a:spLocks noGrp="1"/>
          </p:cNvSpPr>
          <p:nvPr>
            <p:ph type="title" orient="vert"/>
          </p:nvPr>
        </p:nvSpPr>
        <p:spPr>
          <a:xfrm>
            <a:off x="7308854" y="300042"/>
            <a:ext cx="2266953" cy="6457949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 txBox="1">
            <a:spLocks noGrp="1"/>
          </p:cNvSpPr>
          <p:nvPr>
            <p:ph type="body" orient="vert" idx="1"/>
          </p:nvPr>
        </p:nvSpPr>
        <p:spPr>
          <a:xfrm>
            <a:off x="503240" y="300042"/>
            <a:ext cx="6653210" cy="6457949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5" name="Marcador de pie de página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C161298-DCFB-4AF9-B156-8CFE727F3313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9612824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5" name="Marcador de pie de página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DD4F356-7D4A-4BD6-BC8F-92A5960DC9EE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37757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 txBox="1">
            <a:spLocks noGrp="1"/>
          </p:cNvSpPr>
          <p:nvPr>
            <p:ph type="title"/>
          </p:nvPr>
        </p:nvSpPr>
        <p:spPr>
          <a:xfrm>
            <a:off x="687391" y="1884358"/>
            <a:ext cx="8694736" cy="3144841"/>
          </a:xfrm>
        </p:spPr>
        <p:txBody>
          <a:bodyPr anchor="b"/>
          <a:lstStyle>
            <a:lvl1pPr>
              <a:defRPr sz="6000"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 txBox="1">
            <a:spLocks noGrp="1"/>
          </p:cNvSpPr>
          <p:nvPr>
            <p:ph type="body" idx="1"/>
          </p:nvPr>
        </p:nvSpPr>
        <p:spPr>
          <a:xfrm>
            <a:off x="687391" y="5059366"/>
            <a:ext cx="8694736" cy="1652585"/>
          </a:xfrm>
        </p:spPr>
        <p:txBody>
          <a:bodyPr/>
          <a:lstStyle>
            <a:lvl1pPr>
              <a:defRPr sz="2400">
                <a:solidFill>
                  <a:srgbClr val="898989"/>
                </a:solidFill>
              </a:defRPr>
            </a:lvl1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5" name="Marcador de pie de página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6CDF558-1229-4E4F-9441-3F8145E0A8EC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46152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 txBox="1">
            <a:spLocks noGrp="1"/>
          </p:cNvSpPr>
          <p:nvPr>
            <p:ph idx="1"/>
          </p:nvPr>
        </p:nvSpPr>
        <p:spPr>
          <a:xfrm>
            <a:off x="503240" y="1768477"/>
            <a:ext cx="4459291" cy="4989515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 txBox="1">
            <a:spLocks noGrp="1"/>
          </p:cNvSpPr>
          <p:nvPr>
            <p:ph idx="2"/>
          </p:nvPr>
        </p:nvSpPr>
        <p:spPr>
          <a:xfrm>
            <a:off x="5114925" y="1768477"/>
            <a:ext cx="4460872" cy="4989515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pie de página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7" name="Marcador de número de diapositiva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39FA617-49EA-4464-AEB7-F36B32C214F3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82099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 txBox="1">
            <a:spLocks noGrp="1"/>
          </p:cNvSpPr>
          <p:nvPr>
            <p:ph type="title"/>
          </p:nvPr>
        </p:nvSpPr>
        <p:spPr>
          <a:xfrm>
            <a:off x="693736" y="403222"/>
            <a:ext cx="8694736" cy="1460497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 txBox="1">
            <a:spLocks noGrp="1"/>
          </p:cNvSpPr>
          <p:nvPr>
            <p:ph type="body" idx="1"/>
          </p:nvPr>
        </p:nvSpPr>
        <p:spPr>
          <a:xfrm>
            <a:off x="693736" y="1852610"/>
            <a:ext cx="4265611" cy="908054"/>
          </a:xfrm>
        </p:spPr>
        <p:txBody>
          <a:bodyPr anchor="b"/>
          <a:lstStyle>
            <a:lvl1pPr>
              <a:defRPr sz="2400" b="1"/>
            </a:lvl1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 txBox="1">
            <a:spLocks noGrp="1"/>
          </p:cNvSpPr>
          <p:nvPr>
            <p:ph idx="2"/>
          </p:nvPr>
        </p:nvSpPr>
        <p:spPr>
          <a:xfrm>
            <a:off x="693736" y="2760665"/>
            <a:ext cx="4265611" cy="4062414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 txBox="1">
            <a:spLocks noGrp="1"/>
          </p:cNvSpPr>
          <p:nvPr>
            <p:ph type="body" idx="3"/>
          </p:nvPr>
        </p:nvSpPr>
        <p:spPr>
          <a:xfrm>
            <a:off x="5103815" y="1852610"/>
            <a:ext cx="4284658" cy="908054"/>
          </a:xfrm>
        </p:spPr>
        <p:txBody>
          <a:bodyPr anchor="b"/>
          <a:lstStyle>
            <a:lvl1pPr>
              <a:defRPr sz="2400" b="1"/>
            </a:lvl1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 txBox="1">
            <a:spLocks noGrp="1"/>
          </p:cNvSpPr>
          <p:nvPr>
            <p:ph idx="4"/>
          </p:nvPr>
        </p:nvSpPr>
        <p:spPr>
          <a:xfrm>
            <a:off x="5103815" y="2760665"/>
            <a:ext cx="4284658" cy="4062414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8" name="Marcador de pie de página 7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9" name="Marcador de número de diapositiva 8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6FFA3A3-E869-491F-9F99-56CEF217A76E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489955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4" name="Marcador de pie de página 3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5" name="Marcador de número de diapositiva 4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584AF41-3B5B-4276-B455-895AF2C24F5C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767775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3" name="Marcador de pie de página 2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4" name="Marcador de número de diapositiva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F28FDD3-53F6-434F-82AF-76B633D6FC9D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33969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 txBox="1">
            <a:spLocks noGrp="1"/>
          </p:cNvSpPr>
          <p:nvPr>
            <p:ph type="title"/>
          </p:nvPr>
        </p:nvSpPr>
        <p:spPr>
          <a:xfrm>
            <a:off x="693736" y="503240"/>
            <a:ext cx="3251204" cy="1765304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 txBox="1">
            <a:spLocks noGrp="1"/>
          </p:cNvSpPr>
          <p:nvPr>
            <p:ph idx="1"/>
          </p:nvPr>
        </p:nvSpPr>
        <p:spPr>
          <a:xfrm>
            <a:off x="4286249" y="1089022"/>
            <a:ext cx="5102223" cy="5372100"/>
          </a:xfrm>
        </p:spPr>
        <p:txBody>
          <a:bodyPr/>
          <a:lstStyle>
            <a:lvl1pPr>
              <a:defRPr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 txBox="1">
            <a:spLocks noGrp="1"/>
          </p:cNvSpPr>
          <p:nvPr>
            <p:ph type="body" idx="2"/>
          </p:nvPr>
        </p:nvSpPr>
        <p:spPr>
          <a:xfrm>
            <a:off x="693736" y="2268534"/>
            <a:ext cx="3251204" cy="4200525"/>
          </a:xfrm>
        </p:spPr>
        <p:txBody>
          <a:bodyPr/>
          <a:lstStyle>
            <a:lvl1pPr>
              <a:defRPr sz="1600"/>
            </a:lvl1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pie de página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7" name="Marcador de número de diapositiva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D69FC95-7046-44AB-B62B-3DD5C1A2E151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80564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 txBox="1">
            <a:spLocks noGrp="1"/>
          </p:cNvSpPr>
          <p:nvPr>
            <p:ph type="title"/>
          </p:nvPr>
        </p:nvSpPr>
        <p:spPr>
          <a:xfrm>
            <a:off x="693736" y="503240"/>
            <a:ext cx="3251204" cy="1765304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 txBox="1">
            <a:spLocks noGrp="1"/>
          </p:cNvSpPr>
          <p:nvPr>
            <p:ph type="pic" idx="1"/>
          </p:nvPr>
        </p:nvSpPr>
        <p:spPr>
          <a:xfrm>
            <a:off x="4286249" y="1089022"/>
            <a:ext cx="5102223" cy="5372100"/>
          </a:xfrm>
        </p:spPr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4" name="Marcador de texto 3"/>
          <p:cNvSpPr txBox="1">
            <a:spLocks noGrp="1"/>
          </p:cNvSpPr>
          <p:nvPr>
            <p:ph type="body" idx="2"/>
          </p:nvPr>
        </p:nvSpPr>
        <p:spPr>
          <a:xfrm>
            <a:off x="693736" y="2268534"/>
            <a:ext cx="3251204" cy="4200525"/>
          </a:xfrm>
        </p:spPr>
        <p:txBody>
          <a:bodyPr/>
          <a:lstStyle>
            <a:lvl1pPr>
              <a:defRPr sz="1600"/>
            </a:lvl1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pie de página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7" name="Marcador de número de diapositiva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3C39F18-70CA-47B3-BC68-C2D586559BC2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18485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 txBox="1">
            <a:spLocks noGrp="1"/>
          </p:cNvSpPr>
          <p:nvPr>
            <p:ph type="title"/>
          </p:nvPr>
        </p:nvSpPr>
        <p:spPr>
          <a:xfrm>
            <a:off x="503998" y="300599"/>
            <a:ext cx="9071643" cy="1262155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ctr" anchorCtr="1" compatLnSpc="1">
            <a:noAutofit/>
          </a:bodyPr>
          <a:lstStyle/>
          <a:p>
            <a:pPr lvl="0"/>
            <a:endParaRPr lang="es-ES"/>
          </a:p>
        </p:txBody>
      </p:sp>
      <p:sp>
        <p:nvSpPr>
          <p:cNvPr id="3" name="Marcador de texto 2"/>
          <p:cNvSpPr txBox="1">
            <a:spLocks noGrp="1"/>
          </p:cNvSpPr>
          <p:nvPr>
            <p:ph type="body" idx="1"/>
          </p:nvPr>
        </p:nvSpPr>
        <p:spPr>
          <a:xfrm>
            <a:off x="503998" y="1769043"/>
            <a:ext cx="9071643" cy="4989240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t" anchorCtr="0" compatLnSpc="1">
            <a:no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 txBox="1">
            <a:spLocks noGrp="1"/>
          </p:cNvSpPr>
          <p:nvPr>
            <p:ph type="dt" sz="half" idx="2"/>
          </p:nvPr>
        </p:nvSpPr>
        <p:spPr>
          <a:xfrm>
            <a:off x="503998" y="6887160"/>
            <a:ext cx="2348279" cy="521281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t" anchorCtr="0" compatLnSpc="1">
            <a:noAutofit/>
          </a:bodyPr>
          <a:lstStyle>
            <a:lvl1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s-ES" sz="14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endParaRPr lang="es-ES"/>
          </a:p>
        </p:txBody>
      </p:sp>
      <p:sp>
        <p:nvSpPr>
          <p:cNvPr id="5" name="Marcador de pie de página 4"/>
          <p:cNvSpPr txBox="1">
            <a:spLocks noGrp="1"/>
          </p:cNvSpPr>
          <p:nvPr>
            <p:ph type="ftr" sz="quarter" idx="3"/>
          </p:nvPr>
        </p:nvSpPr>
        <p:spPr>
          <a:xfrm>
            <a:off x="3447004" y="6887160"/>
            <a:ext cx="3194995" cy="521281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t" anchorCtr="1" compatLnSpc="1">
            <a:noAutofit/>
          </a:bodyPr>
          <a:lstStyle>
            <a:lvl1pPr marL="0" marR="0" lvl="0" indent="0" algn="ct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s-ES" sz="14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/>
          <p:cNvSpPr txBox="1">
            <a:spLocks noGrp="1"/>
          </p:cNvSpPr>
          <p:nvPr>
            <p:ph type="sldNum" sz="quarter" idx="4"/>
          </p:nvPr>
        </p:nvSpPr>
        <p:spPr>
          <a:xfrm>
            <a:off x="7226996" y="6887160"/>
            <a:ext cx="2348279" cy="521281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t" anchorCtr="0" compatLnSpc="1">
            <a:noAutofit/>
          </a:bodyPr>
          <a:lstStyle>
            <a:lvl1pPr marL="0" marR="0" lvl="0" indent="0" algn="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s-ES" sz="14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fld id="{B1391E5B-DB50-4727-9096-FD1D91597F10}" type="slidenum"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xStyles>
    <p:titleStyle>
      <a:lvl1pPr marL="0" marR="0" lvl="0" indent="0" algn="ctr" defTabSz="914400" rtl="0" fontAlgn="auto" hangingPunct="0">
        <a:lnSpc>
          <a:spcPct val="100000"/>
        </a:lnSpc>
        <a:spcBef>
          <a:spcPts val="0"/>
        </a:spcBef>
        <a:spcAft>
          <a:spcPts val="0"/>
        </a:spcAft>
        <a:buNone/>
        <a:tabLst/>
        <a:defRPr lang="es-ES" sz="4390" b="0" i="0" u="none" strike="noStrike" kern="1200" cap="none" spc="0" baseline="0">
          <a:solidFill>
            <a:srgbClr val="000000"/>
          </a:solidFill>
          <a:uFillTx/>
          <a:latin typeface="Arial" pitchFamily="18"/>
          <a:ea typeface="Microsoft YaHei" pitchFamily="2"/>
          <a:cs typeface="Mangal" pitchFamily="2"/>
        </a:defRPr>
      </a:lvl1pPr>
    </p:titleStyle>
    <p:bodyStyle>
      <a:lvl1pPr marL="0" marR="0" lvl="0" indent="0" defTabSz="914400" rtl="0" fontAlgn="auto" hangingPunct="0">
        <a:lnSpc>
          <a:spcPct val="100000"/>
        </a:lnSpc>
        <a:spcBef>
          <a:spcPts val="0"/>
        </a:spcBef>
        <a:spcAft>
          <a:spcPts val="1410"/>
        </a:spcAft>
        <a:buNone/>
        <a:tabLst/>
        <a:defRPr lang="es-ES" sz="3200" b="0" i="0" u="none" strike="noStrike" kern="1200" cap="none" spc="0" baseline="0">
          <a:solidFill>
            <a:srgbClr val="000000"/>
          </a:solidFill>
          <a:uFillTx/>
          <a:latin typeface="Arial" pitchFamily="18"/>
          <a:ea typeface="Microsoft YaHei" pitchFamily="2"/>
          <a:cs typeface="Mangal" pitchFamily="2"/>
        </a:defRPr>
      </a:lvl1pPr>
      <a:lvl2pPr marL="685800" marR="0" lvl="1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s-ES" sz="2400" b="0" i="0" u="none" strike="noStrike" kern="1200" cap="none" spc="0" baseline="0">
          <a:solidFill>
            <a:srgbClr val="000000"/>
          </a:solidFill>
          <a:uFillTx/>
          <a:latin typeface="Calibri"/>
          <a:ea typeface=""/>
          <a:cs typeface=""/>
        </a:defRPr>
      </a:lvl2pPr>
      <a:lvl3pPr marL="1143000" marR="0" lvl="2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s-ES" sz="2000" b="0" i="0" u="none" strike="noStrike" kern="1200" cap="none" spc="0" baseline="0">
          <a:solidFill>
            <a:srgbClr val="000000"/>
          </a:solidFill>
          <a:uFillTx/>
          <a:latin typeface="Calibri"/>
          <a:ea typeface=""/>
          <a:cs typeface=""/>
        </a:defRPr>
      </a:lvl3pPr>
      <a:lvl4pPr marL="1600200" marR="0" lvl="3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s-ES" sz="1800" b="0" i="0" u="none" strike="noStrike" kern="1200" cap="none" spc="0" baseline="0">
          <a:solidFill>
            <a:srgbClr val="000000"/>
          </a:solidFill>
          <a:uFillTx/>
          <a:latin typeface="Calibri"/>
          <a:ea typeface=""/>
          <a:cs typeface=""/>
        </a:defRPr>
      </a:lvl4pPr>
      <a:lvl5pPr marL="2057400" marR="0" lvl="4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s-ES" sz="1800" b="0" i="0" u="none" strike="noStrike" kern="1200" cap="none" spc="0" baseline="0">
          <a:solidFill>
            <a:srgbClr val="000000"/>
          </a:solidFill>
          <a:uFillTx/>
          <a:latin typeface="Calibri"/>
          <a:ea typeface=""/>
          <a:cs typeface="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rma libre 1"/>
          <p:cNvSpPr/>
          <p:nvPr/>
        </p:nvSpPr>
        <p:spPr>
          <a:xfrm>
            <a:off x="888193" y="661705"/>
            <a:ext cx="3600001" cy="237597"/>
          </a:xfrm>
          <a:custGeom>
            <a:avLst>
              <a:gd name="f10" fmla="val 3600"/>
            </a:avLst>
            <a:gdLst>
              <a:gd name="f1" fmla="val 10800000"/>
              <a:gd name="f2" fmla="val 5400000"/>
              <a:gd name="f3" fmla="val 16200000"/>
              <a:gd name="f4" fmla="val w"/>
              <a:gd name="f5" fmla="val h"/>
              <a:gd name="f6" fmla="val ss"/>
              <a:gd name="f7" fmla="val 0"/>
              <a:gd name="f8" fmla="*/ 5419351 1 1725033"/>
              <a:gd name="f9" fmla="val 45"/>
              <a:gd name="f10" fmla="val 3600"/>
              <a:gd name="f11" fmla="abs f4"/>
              <a:gd name="f12" fmla="abs f5"/>
              <a:gd name="f13" fmla="abs f6"/>
              <a:gd name="f14" fmla="*/ f8 1 180"/>
              <a:gd name="f15" fmla="val f10"/>
              <a:gd name="f16" fmla="+- 0 0 f2"/>
              <a:gd name="f17" fmla="?: f11 f4 1"/>
              <a:gd name="f18" fmla="?: f12 f5 1"/>
              <a:gd name="f19" fmla="?: f13 f6 1"/>
              <a:gd name="f20" fmla="*/ f9 f14 1"/>
              <a:gd name="f21" fmla="+- f7 f15 0"/>
              <a:gd name="f22" fmla="*/ f17 1 21600"/>
              <a:gd name="f23" fmla="*/ f18 1 21600"/>
              <a:gd name="f24" fmla="*/ 21600 f17 1"/>
              <a:gd name="f25" fmla="*/ 21600 f18 1"/>
              <a:gd name="f26" fmla="+- 0 0 f20"/>
              <a:gd name="f27" fmla="+- f7 0 f21"/>
              <a:gd name="f28" fmla="+- f21 0 f7"/>
              <a:gd name="f29" fmla="min f23 f22"/>
              <a:gd name="f30" fmla="*/ f24 1 f19"/>
              <a:gd name="f31" fmla="*/ f25 1 f19"/>
              <a:gd name="f32" fmla="*/ f26 f1 1"/>
              <a:gd name="f33" fmla="abs f27"/>
              <a:gd name="f34" fmla="abs f28"/>
              <a:gd name="f35" fmla="?: f27 f16 f2"/>
              <a:gd name="f36" fmla="?: f27 f2 f16"/>
              <a:gd name="f37" fmla="?: f27 f3 f2"/>
              <a:gd name="f38" fmla="?: f27 f2 f3"/>
              <a:gd name="f39" fmla="?: f28 f16 f2"/>
              <a:gd name="f40" fmla="?: f28 f2 f16"/>
              <a:gd name="f41" fmla="?: f27 0 f1"/>
              <a:gd name="f42" fmla="?: f27 f1 0"/>
              <a:gd name="f43" fmla="val f30"/>
              <a:gd name="f44" fmla="val f31"/>
              <a:gd name="f45" fmla="*/ f32 1 f8"/>
              <a:gd name="f46" fmla="?: f27 f38 f37"/>
              <a:gd name="f47" fmla="?: f27 f37 f38"/>
              <a:gd name="f48" fmla="?: f28 f36 f35"/>
              <a:gd name="f49" fmla="*/ f21 f29 1"/>
              <a:gd name="f50" fmla="*/ f7 f29 1"/>
              <a:gd name="f51" fmla="*/ f33 f29 1"/>
              <a:gd name="f52" fmla="*/ f34 f29 1"/>
              <a:gd name="f53" fmla="+- f44 0 f15"/>
              <a:gd name="f54" fmla="+- f43 0 f15"/>
              <a:gd name="f55" fmla="+- f45 0 f2"/>
              <a:gd name="f56" fmla="?: f28 f47 f46"/>
              <a:gd name="f57" fmla="*/ f44 f29 1"/>
              <a:gd name="f58" fmla="*/ f43 f29 1"/>
              <a:gd name="f59" fmla="+- f55 f2 0"/>
              <a:gd name="f60" fmla="+- f44 0 f53"/>
              <a:gd name="f61" fmla="+- f43 0 f54"/>
              <a:gd name="f62" fmla="+- f53 0 f44"/>
              <a:gd name="f63" fmla="+- f54 0 f43"/>
              <a:gd name="f64" fmla="*/ f53 f29 1"/>
              <a:gd name="f65" fmla="*/ f54 f29 1"/>
              <a:gd name="f66" fmla="*/ f59 f8 1"/>
              <a:gd name="f67" fmla="abs f60"/>
              <a:gd name="f68" fmla="?: f60 0 f1"/>
              <a:gd name="f69" fmla="?: f60 f1 0"/>
              <a:gd name="f70" fmla="?: f60 f39 f40"/>
              <a:gd name="f71" fmla="abs f61"/>
              <a:gd name="f72" fmla="abs f62"/>
              <a:gd name="f73" fmla="?: f61 f16 f2"/>
              <a:gd name="f74" fmla="?: f61 f2 f16"/>
              <a:gd name="f75" fmla="?: f61 f3 f2"/>
              <a:gd name="f76" fmla="?: f61 f2 f3"/>
              <a:gd name="f77" fmla="abs f63"/>
              <a:gd name="f78" fmla="?: f63 f16 f2"/>
              <a:gd name="f79" fmla="?: f63 f2 f16"/>
              <a:gd name="f80" fmla="?: f63 f42 f41"/>
              <a:gd name="f81" fmla="?: f63 f41 f42"/>
              <a:gd name="f82" fmla="*/ f66 1 f1"/>
              <a:gd name="f83" fmla="?: f28 f69 f68"/>
              <a:gd name="f84" fmla="?: f28 f68 f69"/>
              <a:gd name="f85" fmla="?: f61 f76 f75"/>
              <a:gd name="f86" fmla="?: f61 f75 f76"/>
              <a:gd name="f87" fmla="?: f62 f74 f73"/>
              <a:gd name="f88" fmla="?: f27 f80 f81"/>
              <a:gd name="f89" fmla="?: f27 f78 f79"/>
              <a:gd name="f90" fmla="*/ f67 f29 1"/>
              <a:gd name="f91" fmla="*/ f71 f29 1"/>
              <a:gd name="f92" fmla="*/ f72 f29 1"/>
              <a:gd name="f93" fmla="*/ f77 f29 1"/>
              <a:gd name="f94" fmla="+- 0 0 f82"/>
              <a:gd name="f95" fmla="?: f60 f83 f84"/>
              <a:gd name="f96" fmla="?: f62 f86 f85"/>
              <a:gd name="f97" fmla="+- 0 0 f94"/>
              <a:gd name="f98" fmla="*/ f97 f1 1"/>
              <a:gd name="f99" fmla="*/ f98 1 f8"/>
              <a:gd name="f100" fmla="+- f99 0 f2"/>
              <a:gd name="f101" fmla="cos 1 f100"/>
              <a:gd name="f102" fmla="+- 0 0 f101"/>
              <a:gd name="f103" fmla="+- 0 0 f102"/>
              <a:gd name="f104" fmla="val f103"/>
              <a:gd name="f105" fmla="+- 0 0 f104"/>
              <a:gd name="f106" fmla="*/ f15 f105 1"/>
              <a:gd name="f107" fmla="*/ f106 3163 1"/>
              <a:gd name="f108" fmla="*/ f107 1 7636"/>
              <a:gd name="f109" fmla="+- f7 f108 0"/>
              <a:gd name="f110" fmla="+- f43 0 f108"/>
              <a:gd name="f111" fmla="+- f44 0 f108"/>
              <a:gd name="f112" fmla="*/ f109 f29 1"/>
              <a:gd name="f113" fmla="*/ f110 f29 1"/>
              <a:gd name="f114" fmla="*/ f111 f29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2" t="f112" r="f113" b="f114"/>
            <a:pathLst>
              <a:path>
                <a:moveTo>
                  <a:pt x="f49" y="f50"/>
                </a:moveTo>
                <a:arcTo wR="f51" hR="f52" stAng="f56" swAng="f48"/>
                <a:lnTo>
                  <a:pt x="f50" y="f64"/>
                </a:lnTo>
                <a:arcTo wR="f52" hR="f90" stAng="f95" swAng="f70"/>
                <a:lnTo>
                  <a:pt x="f65" y="f57"/>
                </a:lnTo>
                <a:arcTo wR="f91" hR="f92" stAng="f96" swAng="f87"/>
                <a:lnTo>
                  <a:pt x="f58" y="f49"/>
                </a:lnTo>
                <a:arcTo wR="f93" hR="f51" stAng="f88" swAng="f89"/>
                <a:close/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ct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6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NS</a:t>
            </a:r>
          </a:p>
        </p:txBody>
      </p:sp>
      <p:sp>
        <p:nvSpPr>
          <p:cNvPr id="3" name="Conector recto 2"/>
          <p:cNvSpPr/>
          <p:nvPr/>
        </p:nvSpPr>
        <p:spPr>
          <a:xfrm>
            <a:off x="395642" y="756364"/>
            <a:ext cx="503998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4" name="Forma libre 3"/>
          <p:cNvSpPr/>
          <p:nvPr/>
        </p:nvSpPr>
        <p:spPr>
          <a:xfrm>
            <a:off x="4535643" y="647998"/>
            <a:ext cx="4049996" cy="237597"/>
          </a:xfrm>
          <a:custGeom>
            <a:avLst>
              <a:gd name="f10" fmla="val 3600"/>
            </a:avLst>
            <a:gdLst>
              <a:gd name="f1" fmla="val 10800000"/>
              <a:gd name="f2" fmla="val 5400000"/>
              <a:gd name="f3" fmla="val 16200000"/>
              <a:gd name="f4" fmla="val w"/>
              <a:gd name="f5" fmla="val h"/>
              <a:gd name="f6" fmla="val ss"/>
              <a:gd name="f7" fmla="val 0"/>
              <a:gd name="f8" fmla="*/ 5419351 1 1725033"/>
              <a:gd name="f9" fmla="val 45"/>
              <a:gd name="f10" fmla="val 3600"/>
              <a:gd name="f11" fmla="abs f4"/>
              <a:gd name="f12" fmla="abs f5"/>
              <a:gd name="f13" fmla="abs f6"/>
              <a:gd name="f14" fmla="*/ f8 1 180"/>
              <a:gd name="f15" fmla="val f10"/>
              <a:gd name="f16" fmla="+- 0 0 f2"/>
              <a:gd name="f17" fmla="?: f11 f4 1"/>
              <a:gd name="f18" fmla="?: f12 f5 1"/>
              <a:gd name="f19" fmla="?: f13 f6 1"/>
              <a:gd name="f20" fmla="*/ f9 f14 1"/>
              <a:gd name="f21" fmla="+- f7 f15 0"/>
              <a:gd name="f22" fmla="*/ f17 1 21600"/>
              <a:gd name="f23" fmla="*/ f18 1 21600"/>
              <a:gd name="f24" fmla="*/ 21600 f17 1"/>
              <a:gd name="f25" fmla="*/ 21600 f18 1"/>
              <a:gd name="f26" fmla="+- 0 0 f20"/>
              <a:gd name="f27" fmla="+- f7 0 f21"/>
              <a:gd name="f28" fmla="+- f21 0 f7"/>
              <a:gd name="f29" fmla="min f23 f22"/>
              <a:gd name="f30" fmla="*/ f24 1 f19"/>
              <a:gd name="f31" fmla="*/ f25 1 f19"/>
              <a:gd name="f32" fmla="*/ f26 f1 1"/>
              <a:gd name="f33" fmla="abs f27"/>
              <a:gd name="f34" fmla="abs f28"/>
              <a:gd name="f35" fmla="?: f27 f16 f2"/>
              <a:gd name="f36" fmla="?: f27 f2 f16"/>
              <a:gd name="f37" fmla="?: f27 f3 f2"/>
              <a:gd name="f38" fmla="?: f27 f2 f3"/>
              <a:gd name="f39" fmla="?: f28 f16 f2"/>
              <a:gd name="f40" fmla="?: f28 f2 f16"/>
              <a:gd name="f41" fmla="?: f27 0 f1"/>
              <a:gd name="f42" fmla="?: f27 f1 0"/>
              <a:gd name="f43" fmla="val f30"/>
              <a:gd name="f44" fmla="val f31"/>
              <a:gd name="f45" fmla="*/ f32 1 f8"/>
              <a:gd name="f46" fmla="?: f27 f38 f37"/>
              <a:gd name="f47" fmla="?: f27 f37 f38"/>
              <a:gd name="f48" fmla="?: f28 f36 f35"/>
              <a:gd name="f49" fmla="*/ f21 f29 1"/>
              <a:gd name="f50" fmla="*/ f7 f29 1"/>
              <a:gd name="f51" fmla="*/ f33 f29 1"/>
              <a:gd name="f52" fmla="*/ f34 f29 1"/>
              <a:gd name="f53" fmla="+- f44 0 f15"/>
              <a:gd name="f54" fmla="+- f43 0 f15"/>
              <a:gd name="f55" fmla="+- f45 0 f2"/>
              <a:gd name="f56" fmla="?: f28 f47 f46"/>
              <a:gd name="f57" fmla="*/ f44 f29 1"/>
              <a:gd name="f58" fmla="*/ f43 f29 1"/>
              <a:gd name="f59" fmla="+- f55 f2 0"/>
              <a:gd name="f60" fmla="+- f44 0 f53"/>
              <a:gd name="f61" fmla="+- f43 0 f54"/>
              <a:gd name="f62" fmla="+- f53 0 f44"/>
              <a:gd name="f63" fmla="+- f54 0 f43"/>
              <a:gd name="f64" fmla="*/ f53 f29 1"/>
              <a:gd name="f65" fmla="*/ f54 f29 1"/>
              <a:gd name="f66" fmla="*/ f59 f8 1"/>
              <a:gd name="f67" fmla="abs f60"/>
              <a:gd name="f68" fmla="?: f60 0 f1"/>
              <a:gd name="f69" fmla="?: f60 f1 0"/>
              <a:gd name="f70" fmla="?: f60 f39 f40"/>
              <a:gd name="f71" fmla="abs f61"/>
              <a:gd name="f72" fmla="abs f62"/>
              <a:gd name="f73" fmla="?: f61 f16 f2"/>
              <a:gd name="f74" fmla="?: f61 f2 f16"/>
              <a:gd name="f75" fmla="?: f61 f3 f2"/>
              <a:gd name="f76" fmla="?: f61 f2 f3"/>
              <a:gd name="f77" fmla="abs f63"/>
              <a:gd name="f78" fmla="?: f63 f16 f2"/>
              <a:gd name="f79" fmla="?: f63 f2 f16"/>
              <a:gd name="f80" fmla="?: f63 f42 f41"/>
              <a:gd name="f81" fmla="?: f63 f41 f42"/>
              <a:gd name="f82" fmla="*/ f66 1 f1"/>
              <a:gd name="f83" fmla="?: f28 f69 f68"/>
              <a:gd name="f84" fmla="?: f28 f68 f69"/>
              <a:gd name="f85" fmla="?: f61 f76 f75"/>
              <a:gd name="f86" fmla="?: f61 f75 f76"/>
              <a:gd name="f87" fmla="?: f62 f74 f73"/>
              <a:gd name="f88" fmla="?: f27 f80 f81"/>
              <a:gd name="f89" fmla="?: f27 f78 f79"/>
              <a:gd name="f90" fmla="*/ f67 f29 1"/>
              <a:gd name="f91" fmla="*/ f71 f29 1"/>
              <a:gd name="f92" fmla="*/ f72 f29 1"/>
              <a:gd name="f93" fmla="*/ f77 f29 1"/>
              <a:gd name="f94" fmla="+- 0 0 f82"/>
              <a:gd name="f95" fmla="?: f60 f83 f84"/>
              <a:gd name="f96" fmla="?: f62 f86 f85"/>
              <a:gd name="f97" fmla="+- 0 0 f94"/>
              <a:gd name="f98" fmla="*/ f97 f1 1"/>
              <a:gd name="f99" fmla="*/ f98 1 f8"/>
              <a:gd name="f100" fmla="+- f99 0 f2"/>
              <a:gd name="f101" fmla="cos 1 f100"/>
              <a:gd name="f102" fmla="+- 0 0 f101"/>
              <a:gd name="f103" fmla="+- 0 0 f102"/>
              <a:gd name="f104" fmla="val f103"/>
              <a:gd name="f105" fmla="+- 0 0 f104"/>
              <a:gd name="f106" fmla="*/ f15 f105 1"/>
              <a:gd name="f107" fmla="*/ f106 3163 1"/>
              <a:gd name="f108" fmla="*/ f107 1 7636"/>
              <a:gd name="f109" fmla="+- f7 f108 0"/>
              <a:gd name="f110" fmla="+- f43 0 f108"/>
              <a:gd name="f111" fmla="+- f44 0 f108"/>
              <a:gd name="f112" fmla="*/ f109 f29 1"/>
              <a:gd name="f113" fmla="*/ f110 f29 1"/>
              <a:gd name="f114" fmla="*/ f111 f29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2" t="f112" r="f113" b="f114"/>
            <a:pathLst>
              <a:path>
                <a:moveTo>
                  <a:pt x="f49" y="f50"/>
                </a:moveTo>
                <a:arcTo wR="f51" hR="f52" stAng="f56" swAng="f48"/>
                <a:lnTo>
                  <a:pt x="f50" y="f64"/>
                </a:lnTo>
                <a:arcTo wR="f52" hR="f90" stAng="f95" swAng="f70"/>
                <a:lnTo>
                  <a:pt x="f65" y="f57"/>
                </a:lnTo>
                <a:arcTo wR="f91" hR="f92" stAng="f96" swAng="f87"/>
                <a:lnTo>
                  <a:pt x="f58" y="f49"/>
                </a:lnTo>
                <a:arcTo wR="f93" hR="f51" stAng="f88" swAng="f89"/>
                <a:close/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ct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6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VP</a:t>
            </a:r>
          </a:p>
        </p:txBody>
      </p:sp>
      <p:sp>
        <p:nvSpPr>
          <p:cNvPr id="5" name="Conector recto 4"/>
          <p:cNvSpPr/>
          <p:nvPr/>
        </p:nvSpPr>
        <p:spPr>
          <a:xfrm>
            <a:off x="8603644" y="756364"/>
            <a:ext cx="1079997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6" name="Conector recto 5"/>
          <p:cNvSpPr/>
          <p:nvPr/>
        </p:nvSpPr>
        <p:spPr>
          <a:xfrm>
            <a:off x="4499643" y="756364"/>
            <a:ext cx="35999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7" name="Conector recto 8"/>
          <p:cNvSpPr/>
          <p:nvPr/>
        </p:nvSpPr>
        <p:spPr>
          <a:xfrm>
            <a:off x="611642" y="503276"/>
            <a:ext cx="0" cy="467999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custDash>
              <a:ds d="0" sp="0"/>
              <a:ds d="0" sp="0"/>
            </a:custDash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8" name="Conector recto 9"/>
          <p:cNvSpPr/>
          <p:nvPr/>
        </p:nvSpPr>
        <p:spPr>
          <a:xfrm>
            <a:off x="9179643" y="503276"/>
            <a:ext cx="0" cy="467999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custDash>
              <a:ds d="0" sp="0"/>
              <a:ds d="0" sp="0"/>
            </a:custDash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9" name="CuadroTexto 10"/>
          <p:cNvSpPr txBox="1"/>
          <p:nvPr/>
        </p:nvSpPr>
        <p:spPr>
          <a:xfrm>
            <a:off x="395642" y="214920"/>
            <a:ext cx="539998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79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194</a:t>
            </a:r>
          </a:p>
        </p:txBody>
      </p:sp>
      <p:sp>
        <p:nvSpPr>
          <p:cNvPr id="10" name="CuadroTexto 11"/>
          <p:cNvSpPr txBox="1"/>
          <p:nvPr/>
        </p:nvSpPr>
        <p:spPr>
          <a:xfrm>
            <a:off x="8891643" y="215642"/>
            <a:ext cx="611998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79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4848</a:t>
            </a:r>
          </a:p>
        </p:txBody>
      </p:sp>
      <p:sp>
        <p:nvSpPr>
          <p:cNvPr id="11" name="Conector recto 12"/>
          <p:cNvSpPr/>
          <p:nvPr/>
        </p:nvSpPr>
        <p:spPr>
          <a:xfrm>
            <a:off x="611642" y="971275"/>
            <a:ext cx="287999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  <a:tailEnd type="arrow"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12" name="Conector recto 13"/>
          <p:cNvSpPr/>
          <p:nvPr/>
        </p:nvSpPr>
        <p:spPr>
          <a:xfrm flipH="1">
            <a:off x="8891643" y="971275"/>
            <a:ext cx="287999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  <a:tailEnd type="arrow"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13" name="Conector recto 15"/>
          <p:cNvSpPr/>
          <p:nvPr/>
        </p:nvSpPr>
        <p:spPr>
          <a:xfrm>
            <a:off x="395642" y="2231788"/>
            <a:ext cx="503998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14" name="Conector recto 17"/>
          <p:cNvSpPr/>
          <p:nvPr/>
        </p:nvSpPr>
        <p:spPr>
          <a:xfrm>
            <a:off x="8603644" y="2231788"/>
            <a:ext cx="1079997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15" name="Conector recto 18"/>
          <p:cNvSpPr/>
          <p:nvPr/>
        </p:nvSpPr>
        <p:spPr>
          <a:xfrm>
            <a:off x="4499643" y="2231788"/>
            <a:ext cx="35999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16" name="Conector recto 21"/>
          <p:cNvSpPr/>
          <p:nvPr/>
        </p:nvSpPr>
        <p:spPr>
          <a:xfrm>
            <a:off x="683642" y="1979788"/>
            <a:ext cx="0" cy="467999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custDash>
              <a:ds d="0" sp="0"/>
              <a:ds d="0" sp="0"/>
            </a:custDash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17" name="Conector recto 22"/>
          <p:cNvSpPr/>
          <p:nvPr/>
        </p:nvSpPr>
        <p:spPr>
          <a:xfrm>
            <a:off x="9114254" y="2051788"/>
            <a:ext cx="0" cy="791998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custDash>
              <a:ds d="0" sp="0"/>
              <a:ds d="0" sp="0"/>
            </a:custDash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18" name="CuadroTexto 23"/>
          <p:cNvSpPr txBox="1"/>
          <p:nvPr/>
        </p:nvSpPr>
        <p:spPr>
          <a:xfrm>
            <a:off x="467642" y="1691432"/>
            <a:ext cx="539998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79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206</a:t>
            </a:r>
          </a:p>
        </p:txBody>
      </p:sp>
      <p:sp>
        <p:nvSpPr>
          <p:cNvPr id="19" name="CuadroTexto 24"/>
          <p:cNvSpPr txBox="1"/>
          <p:nvPr/>
        </p:nvSpPr>
        <p:spPr>
          <a:xfrm>
            <a:off x="8855643" y="1692145"/>
            <a:ext cx="611998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79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4823</a:t>
            </a:r>
          </a:p>
        </p:txBody>
      </p:sp>
      <p:sp>
        <p:nvSpPr>
          <p:cNvPr id="20" name="Conector recto 25"/>
          <p:cNvSpPr/>
          <p:nvPr/>
        </p:nvSpPr>
        <p:spPr>
          <a:xfrm>
            <a:off x="683642" y="2447431"/>
            <a:ext cx="287999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  <a:tailEnd type="arrow"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21" name="Conector recto 26"/>
          <p:cNvSpPr/>
          <p:nvPr/>
        </p:nvSpPr>
        <p:spPr>
          <a:xfrm flipH="1">
            <a:off x="8826255" y="2843787"/>
            <a:ext cx="287999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  <a:tailEnd type="arrow"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22" name="Conector recto 27"/>
          <p:cNvSpPr/>
          <p:nvPr/>
        </p:nvSpPr>
        <p:spPr>
          <a:xfrm>
            <a:off x="4895642" y="1979788"/>
            <a:ext cx="0" cy="467999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custDash>
              <a:ds d="0" sp="0"/>
              <a:ds d="0" sp="0"/>
            </a:custDash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23" name="CuadroTexto 28"/>
          <p:cNvSpPr txBox="1"/>
          <p:nvPr/>
        </p:nvSpPr>
        <p:spPr>
          <a:xfrm>
            <a:off x="4607643" y="1692145"/>
            <a:ext cx="611998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79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2460</a:t>
            </a:r>
          </a:p>
        </p:txBody>
      </p:sp>
      <p:sp>
        <p:nvSpPr>
          <p:cNvPr id="24" name="Conector recto 29"/>
          <p:cNvSpPr/>
          <p:nvPr/>
        </p:nvSpPr>
        <p:spPr>
          <a:xfrm flipH="1">
            <a:off x="4607643" y="2447787"/>
            <a:ext cx="287999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  <a:tailEnd type="arrow"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25" name="Conector recto 30"/>
          <p:cNvSpPr/>
          <p:nvPr/>
        </p:nvSpPr>
        <p:spPr>
          <a:xfrm>
            <a:off x="4247644" y="1979788"/>
            <a:ext cx="0" cy="881317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custDash>
              <a:ds d="0" sp="0"/>
              <a:ds d="0" sp="0"/>
            </a:custDash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26" name="CuadroTexto 31"/>
          <p:cNvSpPr txBox="1"/>
          <p:nvPr/>
        </p:nvSpPr>
        <p:spPr>
          <a:xfrm>
            <a:off x="3995644" y="1691432"/>
            <a:ext cx="611998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79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2161</a:t>
            </a:r>
          </a:p>
        </p:txBody>
      </p:sp>
      <p:sp>
        <p:nvSpPr>
          <p:cNvPr id="27" name="Conector recto 32"/>
          <p:cNvSpPr/>
          <p:nvPr/>
        </p:nvSpPr>
        <p:spPr>
          <a:xfrm>
            <a:off x="4247644" y="2847993"/>
            <a:ext cx="287999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val f6"/>
              <a:gd name="f13" fmla="*/ f7 f0 1"/>
              <a:gd name="f14" fmla="*/ f8 f0 1"/>
              <a:gd name="f15" fmla="?: f9 f3 1"/>
              <a:gd name="f16" fmla="?: f10 f4 1"/>
              <a:gd name="f17" fmla="?: f11 f5 1"/>
              <a:gd name="f18" fmla="*/ f13 1 f2"/>
              <a:gd name="f19" fmla="*/ f14 1 f2"/>
              <a:gd name="f20" fmla="*/ f15 1 21600"/>
              <a:gd name="f21" fmla="*/ f16 1 21600"/>
              <a:gd name="f22" fmla="*/ 21600 f15 1"/>
              <a:gd name="f23" fmla="*/ 21600 f16 1"/>
              <a:gd name="f24" fmla="+- f18 0 f1"/>
              <a:gd name="f25" fmla="+- f19 0 f1"/>
              <a:gd name="f26" fmla="min f21 f20"/>
              <a:gd name="f27" fmla="*/ f22 1 f17"/>
              <a:gd name="f28" fmla="*/ f23 1 f17"/>
              <a:gd name="f29" fmla="val f27"/>
              <a:gd name="f30" fmla="val f28"/>
              <a:gd name="f31" fmla="*/ f6 f26 1"/>
              <a:gd name="f32" fmla="*/ f27 f26 1"/>
              <a:gd name="f33" fmla="*/ f28 f26 1"/>
              <a:gd name="f34" fmla="*/ f12 f26 1"/>
              <a:gd name="f35" fmla="*/ f29 f26 1"/>
              <a:gd name="f36" fmla="*/ f30 f2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4">
                <a:pos x="f34" y="f34"/>
              </a:cxn>
              <a:cxn ang="f25">
                <a:pos x="f35" y="f36"/>
              </a:cxn>
            </a:cxnLst>
            <a:rect l="f31" t="f31" r="f32" b="f33"/>
            <a:pathLst>
              <a:path>
                <a:moveTo>
                  <a:pt x="f34" y="f34"/>
                </a:moveTo>
                <a:lnTo>
                  <a:pt x="f35" y="f36"/>
                </a:lnTo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  <a:tailEnd type="arrow"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s-ES" sz="1800" b="0" i="0" u="none" strike="noStrike" kern="1200" cap="none" spc="0" baseline="0">
              <a:solidFill>
                <a:srgbClr val="000000"/>
              </a:solidFill>
              <a:uFillTx/>
              <a:latin typeface="Arial" pitchFamily="18"/>
              <a:ea typeface="Microsoft YaHei" pitchFamily="2"/>
              <a:cs typeface="Mangal" pitchFamily="2"/>
            </a:endParaRPr>
          </a:p>
        </p:txBody>
      </p:sp>
      <p:sp>
        <p:nvSpPr>
          <p:cNvPr id="28" name="CuadroTexto 33"/>
          <p:cNvSpPr txBox="1"/>
          <p:nvPr/>
        </p:nvSpPr>
        <p:spPr>
          <a:xfrm>
            <a:off x="467642" y="1043275"/>
            <a:ext cx="899998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22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F194</a:t>
            </a:r>
          </a:p>
        </p:txBody>
      </p:sp>
      <p:sp>
        <p:nvSpPr>
          <p:cNvPr id="29" name="CuadroTexto 34"/>
          <p:cNvSpPr txBox="1"/>
          <p:nvPr/>
        </p:nvSpPr>
        <p:spPr>
          <a:xfrm>
            <a:off x="8783644" y="1043275"/>
            <a:ext cx="899998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22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R4848</a:t>
            </a:r>
          </a:p>
        </p:txBody>
      </p:sp>
      <p:sp>
        <p:nvSpPr>
          <p:cNvPr id="30" name="CuadroTexto 35"/>
          <p:cNvSpPr txBox="1"/>
          <p:nvPr/>
        </p:nvSpPr>
        <p:spPr>
          <a:xfrm>
            <a:off x="8675644" y="2995705"/>
            <a:ext cx="719998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22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4823R</a:t>
            </a:r>
          </a:p>
        </p:txBody>
      </p:sp>
      <p:sp>
        <p:nvSpPr>
          <p:cNvPr id="31" name="CuadroTexto 36"/>
          <p:cNvSpPr txBox="1"/>
          <p:nvPr/>
        </p:nvSpPr>
        <p:spPr>
          <a:xfrm>
            <a:off x="4211644" y="2937412"/>
            <a:ext cx="791998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22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2161F</a:t>
            </a:r>
          </a:p>
        </p:txBody>
      </p:sp>
      <p:sp>
        <p:nvSpPr>
          <p:cNvPr id="32" name="CuadroTexto 37"/>
          <p:cNvSpPr txBox="1"/>
          <p:nvPr/>
        </p:nvSpPr>
        <p:spPr>
          <a:xfrm>
            <a:off x="4301639" y="2491706"/>
            <a:ext cx="1126796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22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NS-Rext</a:t>
            </a:r>
          </a:p>
        </p:txBody>
      </p:sp>
      <p:sp>
        <p:nvSpPr>
          <p:cNvPr id="33" name="CuadroTexto 38"/>
          <p:cNvSpPr txBox="1"/>
          <p:nvPr/>
        </p:nvSpPr>
        <p:spPr>
          <a:xfrm>
            <a:off x="467642" y="2555641"/>
            <a:ext cx="899998" cy="29734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t" anchorCtr="0" compatLnSpc="0">
            <a:spAutoFit/>
          </a:bodyPr>
          <a:lstStyle/>
          <a:p>
            <a:pPr marL="0" marR="0" lvl="0" indent="0" algn="l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22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4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NS-Fext</a:t>
            </a:r>
          </a:p>
        </p:txBody>
      </p:sp>
      <p:sp>
        <p:nvSpPr>
          <p:cNvPr id="35" name="Forma libre 49"/>
          <p:cNvSpPr/>
          <p:nvPr/>
        </p:nvSpPr>
        <p:spPr>
          <a:xfrm>
            <a:off x="890643" y="2116647"/>
            <a:ext cx="3600001" cy="237597"/>
          </a:xfrm>
          <a:custGeom>
            <a:avLst>
              <a:gd name="f10" fmla="val 3600"/>
            </a:avLst>
            <a:gdLst>
              <a:gd name="f1" fmla="val 10800000"/>
              <a:gd name="f2" fmla="val 5400000"/>
              <a:gd name="f3" fmla="val 16200000"/>
              <a:gd name="f4" fmla="val w"/>
              <a:gd name="f5" fmla="val h"/>
              <a:gd name="f6" fmla="val ss"/>
              <a:gd name="f7" fmla="val 0"/>
              <a:gd name="f8" fmla="*/ 5419351 1 1725033"/>
              <a:gd name="f9" fmla="val 45"/>
              <a:gd name="f10" fmla="val 3600"/>
              <a:gd name="f11" fmla="abs f4"/>
              <a:gd name="f12" fmla="abs f5"/>
              <a:gd name="f13" fmla="abs f6"/>
              <a:gd name="f14" fmla="*/ f8 1 180"/>
              <a:gd name="f15" fmla="val f10"/>
              <a:gd name="f16" fmla="+- 0 0 f2"/>
              <a:gd name="f17" fmla="?: f11 f4 1"/>
              <a:gd name="f18" fmla="?: f12 f5 1"/>
              <a:gd name="f19" fmla="?: f13 f6 1"/>
              <a:gd name="f20" fmla="*/ f9 f14 1"/>
              <a:gd name="f21" fmla="+- f7 f15 0"/>
              <a:gd name="f22" fmla="*/ f17 1 21600"/>
              <a:gd name="f23" fmla="*/ f18 1 21600"/>
              <a:gd name="f24" fmla="*/ 21600 f17 1"/>
              <a:gd name="f25" fmla="*/ 21600 f18 1"/>
              <a:gd name="f26" fmla="+- 0 0 f20"/>
              <a:gd name="f27" fmla="+- f7 0 f21"/>
              <a:gd name="f28" fmla="+- f21 0 f7"/>
              <a:gd name="f29" fmla="min f23 f22"/>
              <a:gd name="f30" fmla="*/ f24 1 f19"/>
              <a:gd name="f31" fmla="*/ f25 1 f19"/>
              <a:gd name="f32" fmla="*/ f26 f1 1"/>
              <a:gd name="f33" fmla="abs f27"/>
              <a:gd name="f34" fmla="abs f28"/>
              <a:gd name="f35" fmla="?: f27 f16 f2"/>
              <a:gd name="f36" fmla="?: f27 f2 f16"/>
              <a:gd name="f37" fmla="?: f27 f3 f2"/>
              <a:gd name="f38" fmla="?: f27 f2 f3"/>
              <a:gd name="f39" fmla="?: f28 f16 f2"/>
              <a:gd name="f40" fmla="?: f28 f2 f16"/>
              <a:gd name="f41" fmla="?: f27 0 f1"/>
              <a:gd name="f42" fmla="?: f27 f1 0"/>
              <a:gd name="f43" fmla="val f30"/>
              <a:gd name="f44" fmla="val f31"/>
              <a:gd name="f45" fmla="*/ f32 1 f8"/>
              <a:gd name="f46" fmla="?: f27 f38 f37"/>
              <a:gd name="f47" fmla="?: f27 f37 f38"/>
              <a:gd name="f48" fmla="?: f28 f36 f35"/>
              <a:gd name="f49" fmla="*/ f21 f29 1"/>
              <a:gd name="f50" fmla="*/ f7 f29 1"/>
              <a:gd name="f51" fmla="*/ f33 f29 1"/>
              <a:gd name="f52" fmla="*/ f34 f29 1"/>
              <a:gd name="f53" fmla="+- f44 0 f15"/>
              <a:gd name="f54" fmla="+- f43 0 f15"/>
              <a:gd name="f55" fmla="+- f45 0 f2"/>
              <a:gd name="f56" fmla="?: f28 f47 f46"/>
              <a:gd name="f57" fmla="*/ f44 f29 1"/>
              <a:gd name="f58" fmla="*/ f43 f29 1"/>
              <a:gd name="f59" fmla="+- f55 f2 0"/>
              <a:gd name="f60" fmla="+- f44 0 f53"/>
              <a:gd name="f61" fmla="+- f43 0 f54"/>
              <a:gd name="f62" fmla="+- f53 0 f44"/>
              <a:gd name="f63" fmla="+- f54 0 f43"/>
              <a:gd name="f64" fmla="*/ f53 f29 1"/>
              <a:gd name="f65" fmla="*/ f54 f29 1"/>
              <a:gd name="f66" fmla="*/ f59 f8 1"/>
              <a:gd name="f67" fmla="abs f60"/>
              <a:gd name="f68" fmla="?: f60 0 f1"/>
              <a:gd name="f69" fmla="?: f60 f1 0"/>
              <a:gd name="f70" fmla="?: f60 f39 f40"/>
              <a:gd name="f71" fmla="abs f61"/>
              <a:gd name="f72" fmla="abs f62"/>
              <a:gd name="f73" fmla="?: f61 f16 f2"/>
              <a:gd name="f74" fmla="?: f61 f2 f16"/>
              <a:gd name="f75" fmla="?: f61 f3 f2"/>
              <a:gd name="f76" fmla="?: f61 f2 f3"/>
              <a:gd name="f77" fmla="abs f63"/>
              <a:gd name="f78" fmla="?: f63 f16 f2"/>
              <a:gd name="f79" fmla="?: f63 f2 f16"/>
              <a:gd name="f80" fmla="?: f63 f42 f41"/>
              <a:gd name="f81" fmla="?: f63 f41 f42"/>
              <a:gd name="f82" fmla="*/ f66 1 f1"/>
              <a:gd name="f83" fmla="?: f28 f69 f68"/>
              <a:gd name="f84" fmla="?: f28 f68 f69"/>
              <a:gd name="f85" fmla="?: f61 f76 f75"/>
              <a:gd name="f86" fmla="?: f61 f75 f76"/>
              <a:gd name="f87" fmla="?: f62 f74 f73"/>
              <a:gd name="f88" fmla="?: f27 f80 f81"/>
              <a:gd name="f89" fmla="?: f27 f78 f79"/>
              <a:gd name="f90" fmla="*/ f67 f29 1"/>
              <a:gd name="f91" fmla="*/ f71 f29 1"/>
              <a:gd name="f92" fmla="*/ f72 f29 1"/>
              <a:gd name="f93" fmla="*/ f77 f29 1"/>
              <a:gd name="f94" fmla="+- 0 0 f82"/>
              <a:gd name="f95" fmla="?: f60 f83 f84"/>
              <a:gd name="f96" fmla="?: f62 f86 f85"/>
              <a:gd name="f97" fmla="+- 0 0 f94"/>
              <a:gd name="f98" fmla="*/ f97 f1 1"/>
              <a:gd name="f99" fmla="*/ f98 1 f8"/>
              <a:gd name="f100" fmla="+- f99 0 f2"/>
              <a:gd name="f101" fmla="cos 1 f100"/>
              <a:gd name="f102" fmla="+- 0 0 f101"/>
              <a:gd name="f103" fmla="+- 0 0 f102"/>
              <a:gd name="f104" fmla="val f103"/>
              <a:gd name="f105" fmla="+- 0 0 f104"/>
              <a:gd name="f106" fmla="*/ f15 f105 1"/>
              <a:gd name="f107" fmla="*/ f106 3163 1"/>
              <a:gd name="f108" fmla="*/ f107 1 7636"/>
              <a:gd name="f109" fmla="+- f7 f108 0"/>
              <a:gd name="f110" fmla="+- f43 0 f108"/>
              <a:gd name="f111" fmla="+- f44 0 f108"/>
              <a:gd name="f112" fmla="*/ f109 f29 1"/>
              <a:gd name="f113" fmla="*/ f110 f29 1"/>
              <a:gd name="f114" fmla="*/ f111 f29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2" t="f112" r="f113" b="f114"/>
            <a:pathLst>
              <a:path>
                <a:moveTo>
                  <a:pt x="f49" y="f50"/>
                </a:moveTo>
                <a:arcTo wR="f51" hR="f52" stAng="f56" swAng="f48"/>
                <a:lnTo>
                  <a:pt x="f50" y="f64"/>
                </a:lnTo>
                <a:arcTo wR="f52" hR="f90" stAng="f95" swAng="f70"/>
                <a:lnTo>
                  <a:pt x="f65" y="f57"/>
                </a:lnTo>
                <a:arcTo wR="f91" hR="f92" stAng="f96" swAng="f87"/>
                <a:lnTo>
                  <a:pt x="f58" y="f49"/>
                </a:lnTo>
                <a:arcTo wR="f93" hR="f51" stAng="f88" swAng="f89"/>
                <a:close/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ct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6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NS</a:t>
            </a:r>
          </a:p>
        </p:txBody>
      </p:sp>
      <p:sp>
        <p:nvSpPr>
          <p:cNvPr id="36" name="Forma libre 50"/>
          <p:cNvSpPr/>
          <p:nvPr/>
        </p:nvSpPr>
        <p:spPr>
          <a:xfrm>
            <a:off x="4535643" y="2116647"/>
            <a:ext cx="4049996" cy="237597"/>
          </a:xfrm>
          <a:custGeom>
            <a:avLst>
              <a:gd name="f10" fmla="val 3600"/>
            </a:avLst>
            <a:gdLst>
              <a:gd name="f1" fmla="val 10800000"/>
              <a:gd name="f2" fmla="val 5400000"/>
              <a:gd name="f3" fmla="val 16200000"/>
              <a:gd name="f4" fmla="val w"/>
              <a:gd name="f5" fmla="val h"/>
              <a:gd name="f6" fmla="val ss"/>
              <a:gd name="f7" fmla="val 0"/>
              <a:gd name="f8" fmla="*/ 5419351 1 1725033"/>
              <a:gd name="f9" fmla="val 45"/>
              <a:gd name="f10" fmla="val 3600"/>
              <a:gd name="f11" fmla="abs f4"/>
              <a:gd name="f12" fmla="abs f5"/>
              <a:gd name="f13" fmla="abs f6"/>
              <a:gd name="f14" fmla="*/ f8 1 180"/>
              <a:gd name="f15" fmla="val f10"/>
              <a:gd name="f16" fmla="+- 0 0 f2"/>
              <a:gd name="f17" fmla="?: f11 f4 1"/>
              <a:gd name="f18" fmla="?: f12 f5 1"/>
              <a:gd name="f19" fmla="?: f13 f6 1"/>
              <a:gd name="f20" fmla="*/ f9 f14 1"/>
              <a:gd name="f21" fmla="+- f7 f15 0"/>
              <a:gd name="f22" fmla="*/ f17 1 21600"/>
              <a:gd name="f23" fmla="*/ f18 1 21600"/>
              <a:gd name="f24" fmla="*/ 21600 f17 1"/>
              <a:gd name="f25" fmla="*/ 21600 f18 1"/>
              <a:gd name="f26" fmla="+- 0 0 f20"/>
              <a:gd name="f27" fmla="+- f7 0 f21"/>
              <a:gd name="f28" fmla="+- f21 0 f7"/>
              <a:gd name="f29" fmla="min f23 f22"/>
              <a:gd name="f30" fmla="*/ f24 1 f19"/>
              <a:gd name="f31" fmla="*/ f25 1 f19"/>
              <a:gd name="f32" fmla="*/ f26 f1 1"/>
              <a:gd name="f33" fmla="abs f27"/>
              <a:gd name="f34" fmla="abs f28"/>
              <a:gd name="f35" fmla="?: f27 f16 f2"/>
              <a:gd name="f36" fmla="?: f27 f2 f16"/>
              <a:gd name="f37" fmla="?: f27 f3 f2"/>
              <a:gd name="f38" fmla="?: f27 f2 f3"/>
              <a:gd name="f39" fmla="?: f28 f16 f2"/>
              <a:gd name="f40" fmla="?: f28 f2 f16"/>
              <a:gd name="f41" fmla="?: f27 0 f1"/>
              <a:gd name="f42" fmla="?: f27 f1 0"/>
              <a:gd name="f43" fmla="val f30"/>
              <a:gd name="f44" fmla="val f31"/>
              <a:gd name="f45" fmla="*/ f32 1 f8"/>
              <a:gd name="f46" fmla="?: f27 f38 f37"/>
              <a:gd name="f47" fmla="?: f27 f37 f38"/>
              <a:gd name="f48" fmla="?: f28 f36 f35"/>
              <a:gd name="f49" fmla="*/ f21 f29 1"/>
              <a:gd name="f50" fmla="*/ f7 f29 1"/>
              <a:gd name="f51" fmla="*/ f33 f29 1"/>
              <a:gd name="f52" fmla="*/ f34 f29 1"/>
              <a:gd name="f53" fmla="+- f44 0 f15"/>
              <a:gd name="f54" fmla="+- f43 0 f15"/>
              <a:gd name="f55" fmla="+- f45 0 f2"/>
              <a:gd name="f56" fmla="?: f28 f47 f46"/>
              <a:gd name="f57" fmla="*/ f44 f29 1"/>
              <a:gd name="f58" fmla="*/ f43 f29 1"/>
              <a:gd name="f59" fmla="+- f55 f2 0"/>
              <a:gd name="f60" fmla="+- f44 0 f53"/>
              <a:gd name="f61" fmla="+- f43 0 f54"/>
              <a:gd name="f62" fmla="+- f53 0 f44"/>
              <a:gd name="f63" fmla="+- f54 0 f43"/>
              <a:gd name="f64" fmla="*/ f53 f29 1"/>
              <a:gd name="f65" fmla="*/ f54 f29 1"/>
              <a:gd name="f66" fmla="*/ f59 f8 1"/>
              <a:gd name="f67" fmla="abs f60"/>
              <a:gd name="f68" fmla="?: f60 0 f1"/>
              <a:gd name="f69" fmla="?: f60 f1 0"/>
              <a:gd name="f70" fmla="?: f60 f39 f40"/>
              <a:gd name="f71" fmla="abs f61"/>
              <a:gd name="f72" fmla="abs f62"/>
              <a:gd name="f73" fmla="?: f61 f16 f2"/>
              <a:gd name="f74" fmla="?: f61 f2 f16"/>
              <a:gd name="f75" fmla="?: f61 f3 f2"/>
              <a:gd name="f76" fmla="?: f61 f2 f3"/>
              <a:gd name="f77" fmla="abs f63"/>
              <a:gd name="f78" fmla="?: f63 f16 f2"/>
              <a:gd name="f79" fmla="?: f63 f2 f16"/>
              <a:gd name="f80" fmla="?: f63 f42 f41"/>
              <a:gd name="f81" fmla="?: f63 f41 f42"/>
              <a:gd name="f82" fmla="*/ f66 1 f1"/>
              <a:gd name="f83" fmla="?: f28 f69 f68"/>
              <a:gd name="f84" fmla="?: f28 f68 f69"/>
              <a:gd name="f85" fmla="?: f61 f76 f75"/>
              <a:gd name="f86" fmla="?: f61 f75 f76"/>
              <a:gd name="f87" fmla="?: f62 f74 f73"/>
              <a:gd name="f88" fmla="?: f27 f80 f81"/>
              <a:gd name="f89" fmla="?: f27 f78 f79"/>
              <a:gd name="f90" fmla="*/ f67 f29 1"/>
              <a:gd name="f91" fmla="*/ f71 f29 1"/>
              <a:gd name="f92" fmla="*/ f72 f29 1"/>
              <a:gd name="f93" fmla="*/ f77 f29 1"/>
              <a:gd name="f94" fmla="+- 0 0 f82"/>
              <a:gd name="f95" fmla="?: f60 f83 f84"/>
              <a:gd name="f96" fmla="?: f62 f86 f85"/>
              <a:gd name="f97" fmla="+- 0 0 f94"/>
              <a:gd name="f98" fmla="*/ f97 f1 1"/>
              <a:gd name="f99" fmla="*/ f98 1 f8"/>
              <a:gd name="f100" fmla="+- f99 0 f2"/>
              <a:gd name="f101" fmla="cos 1 f100"/>
              <a:gd name="f102" fmla="+- 0 0 f101"/>
              <a:gd name="f103" fmla="+- 0 0 f102"/>
              <a:gd name="f104" fmla="val f103"/>
              <a:gd name="f105" fmla="+- 0 0 f104"/>
              <a:gd name="f106" fmla="*/ f15 f105 1"/>
              <a:gd name="f107" fmla="*/ f106 3163 1"/>
              <a:gd name="f108" fmla="*/ f107 1 7636"/>
              <a:gd name="f109" fmla="+- f7 f108 0"/>
              <a:gd name="f110" fmla="+- f43 0 f108"/>
              <a:gd name="f111" fmla="+- f44 0 f108"/>
              <a:gd name="f112" fmla="*/ f109 f29 1"/>
              <a:gd name="f113" fmla="*/ f110 f29 1"/>
              <a:gd name="f114" fmla="*/ f111 f29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2" t="f112" r="f113" b="f114"/>
            <a:pathLst>
              <a:path>
                <a:moveTo>
                  <a:pt x="f49" y="f50"/>
                </a:moveTo>
                <a:arcTo wR="f51" hR="f52" stAng="f56" swAng="f48"/>
                <a:lnTo>
                  <a:pt x="f50" y="f64"/>
                </a:lnTo>
                <a:arcTo wR="f52" hR="f90" stAng="f95" swAng="f70"/>
                <a:lnTo>
                  <a:pt x="f65" y="f57"/>
                </a:lnTo>
                <a:arcTo wR="f91" hR="f92" stAng="f96" swAng="f87"/>
                <a:lnTo>
                  <a:pt x="f58" y="f49"/>
                </a:lnTo>
                <a:arcTo wR="f93" hR="f51" stAng="f88" swAng="f89"/>
                <a:close/>
              </a:path>
            </a:pathLst>
          </a:custGeom>
          <a:noFill/>
          <a:ln w="0" cap="flat">
            <a:solidFill>
              <a:srgbClr val="000000"/>
            </a:solidFill>
            <a:prstDash val="solid"/>
            <a:miter/>
          </a:ln>
        </p:spPr>
        <p:txBody>
          <a:bodyPr vert="horz" wrap="square" lIns="90004" tIns="44997" rIns="90004" bIns="44997" anchor="ctr" anchorCtr="1" compatLnSpc="0">
            <a:noAutofit/>
          </a:bodyPr>
          <a:lstStyle/>
          <a:p>
            <a:pPr marL="0" marR="0" lvl="0" indent="0" algn="ct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600" b="1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Microsoft YaHei" pitchFamily="2"/>
                <a:cs typeface="Mangal" pitchFamily="2"/>
              </a:rPr>
              <a:t>VP</a:t>
            </a:r>
          </a:p>
        </p:txBody>
      </p:sp>
      <p:graphicFrame>
        <p:nvGraphicFramePr>
          <p:cNvPr id="34" name="Tabla 4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0080013"/>
              </p:ext>
            </p:extLst>
          </p:nvPr>
        </p:nvGraphicFramePr>
        <p:xfrm>
          <a:off x="1474817" y="3494074"/>
          <a:ext cx="7173887" cy="3017520"/>
        </p:xfrm>
        <a:graphic>
          <a:graphicData uri="http://schemas.openxmlformats.org/drawingml/2006/table">
            <a:tbl>
              <a:tblPr>
                <a:effectLst/>
              </a:tblPr>
              <a:tblGrid>
                <a:gridCol w="1458888"/>
                <a:gridCol w="3771899"/>
                <a:gridCol w="914400"/>
                <a:gridCol w="1028700"/>
              </a:tblGrid>
              <a:tr h="0"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Primer</a:t>
                      </a:r>
                      <a:endParaRPr lang="es-ES" sz="1200" dirty="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Sequence 5´→3´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Direction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Position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F194</a:t>
                      </a:r>
                      <a:endParaRPr lang="es-ES" sz="1200" dirty="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ATAAAAGACAAACCATAGACCGTTACTGAC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forward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194–223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R4848</a:t>
                      </a:r>
                      <a:endParaRPr lang="es-ES" sz="1200" dirty="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CTTAACATATTCTAAGGGCAAACCAACCAA</a:t>
                      </a:r>
                      <a:endParaRPr lang="es-ES" sz="1200" dirty="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reverse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4819–4848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NS-</a:t>
                      </a:r>
                      <a:r>
                        <a:rPr lang="en-US" sz="1200" dirty="0" err="1" smtClean="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Fext</a:t>
                      </a:r>
                      <a:endParaRPr lang="es-ES" sz="1200" dirty="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GACCGTTACTGACATTCGCTTC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forward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206–227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NS-</a:t>
                      </a:r>
                      <a:r>
                        <a:rPr lang="en-US" sz="1200" dirty="0" err="1" smtClean="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Rext</a:t>
                      </a:r>
                      <a:endParaRPr lang="es-ES" sz="1200" dirty="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GAAGGGTTAGTTGGTTCTCC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reverse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2441–2460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2161F</a:t>
                      </a:r>
                      <a:endParaRPr lang="es-ES" sz="1200" dirty="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TTGGCGTTACTCACAAAGACGTGC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forward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2161–2184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4823R</a:t>
                      </a:r>
                      <a:endParaRPr lang="es-ES" sz="1200" dirty="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ACCAACCACCCACACCATAACAAC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reverse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4800–4823</a:t>
                      </a:r>
                      <a:endParaRPr lang="es-ES" sz="1200"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NS-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Fint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 *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GTTGAAACCACAGTGACGACAG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forward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1055–1076</a:t>
                      </a:r>
                      <a:endParaRPr lang="es-ES" sz="120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NS-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Rint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 *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CATCATCCAGTCTTCAGGTG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reverse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1167–1186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R2 *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TTTTGAATCCAATCTCCTTCTGGAT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reverse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4011–4035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3475R *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GTTGGTGTGCCACTAGTTCCAGTA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reverse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itchFamily="18"/>
                          <a:ea typeface="Cambria" pitchFamily="18"/>
                          <a:cs typeface="Times New Roman" pitchFamily="18"/>
                        </a:rPr>
                        <a:t>3452–3475</a:t>
                      </a:r>
                      <a:endParaRPr lang="es-ES" sz="1200" dirty="0">
                        <a:solidFill>
                          <a:schemeClr val="tx1"/>
                        </a:solidFill>
                        <a:latin typeface="Cambria" pitchFamily="18"/>
                        <a:ea typeface="Cambria" pitchFamily="18"/>
                        <a:cs typeface="Times New Roman" pitchFamily="18"/>
                      </a:endParaRPr>
                    </a:p>
                  </a:txBody>
                  <a:tcPr marL="68580" marR="68580" marT="0" marB="0" anchor="ctr">
                    <a:lnL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1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7" name="CuadroTexto 36"/>
          <p:cNvSpPr txBox="1"/>
          <p:nvPr/>
        </p:nvSpPr>
        <p:spPr>
          <a:xfrm>
            <a:off x="1367640" y="1038488"/>
            <a:ext cx="1893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Molecular </a:t>
            </a:r>
            <a:r>
              <a:rPr lang="es-ES" b="1" dirty="0" err="1" smtClean="0"/>
              <a:t>cloning</a:t>
            </a:r>
            <a:endParaRPr lang="es-ES" b="1" dirty="0"/>
          </a:p>
        </p:txBody>
      </p:sp>
      <p:sp>
        <p:nvSpPr>
          <p:cNvPr id="38" name="CuadroTexto 37"/>
          <p:cNvSpPr txBox="1"/>
          <p:nvPr/>
        </p:nvSpPr>
        <p:spPr>
          <a:xfrm>
            <a:off x="1371538" y="2585175"/>
            <a:ext cx="18149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Deep </a:t>
            </a:r>
            <a:r>
              <a:rPr lang="es-ES" b="1" dirty="0" err="1" smtClean="0"/>
              <a:t>sequencing</a:t>
            </a:r>
            <a:endParaRPr lang="es-ES" b="1" dirty="0"/>
          </a:p>
        </p:txBody>
      </p:sp>
      <p:sp>
        <p:nvSpPr>
          <p:cNvPr id="39" name="CuadroTexto 38"/>
          <p:cNvSpPr txBox="1"/>
          <p:nvPr/>
        </p:nvSpPr>
        <p:spPr>
          <a:xfrm>
            <a:off x="827641" y="6589486"/>
            <a:ext cx="75035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 smtClean="0"/>
              <a:t>Supplementary</a:t>
            </a:r>
            <a:r>
              <a:rPr lang="es-ES" sz="1200" b="1" dirty="0" smtClean="0"/>
              <a:t> Figure S1</a:t>
            </a:r>
            <a:r>
              <a:rPr lang="es-ES" sz="1200" dirty="0" smtClean="0"/>
              <a:t>. </a:t>
            </a:r>
            <a:r>
              <a:rPr lang="es-ES" sz="1200" dirty="0" err="1" smtClean="0"/>
              <a:t>Amplicons</a:t>
            </a:r>
            <a:r>
              <a:rPr lang="es-ES" sz="1200" dirty="0" smtClean="0"/>
              <a:t> and </a:t>
            </a:r>
            <a:r>
              <a:rPr lang="es-ES" sz="1200" dirty="0" err="1" smtClean="0"/>
              <a:t>primers</a:t>
            </a:r>
            <a:r>
              <a:rPr lang="es-ES" sz="1200" dirty="0" smtClean="0"/>
              <a:t> </a:t>
            </a:r>
            <a:r>
              <a:rPr lang="es-ES" sz="1200" dirty="0" err="1" smtClean="0"/>
              <a:t>used</a:t>
            </a:r>
            <a:r>
              <a:rPr lang="es-ES" sz="1200" dirty="0" smtClean="0"/>
              <a:t> in </a:t>
            </a:r>
            <a:r>
              <a:rPr lang="es-ES" sz="1200" dirty="0" err="1" smtClean="0"/>
              <a:t>the</a:t>
            </a:r>
            <a:r>
              <a:rPr lang="es-ES" sz="1200" dirty="0" smtClean="0"/>
              <a:t> molecular </a:t>
            </a:r>
            <a:r>
              <a:rPr lang="es-ES" sz="1200" dirty="0" err="1" smtClean="0"/>
              <a:t>cloning</a:t>
            </a:r>
            <a:r>
              <a:rPr lang="es-ES" sz="1200" dirty="0" smtClean="0"/>
              <a:t> and </a:t>
            </a:r>
            <a:r>
              <a:rPr lang="es-ES" sz="1200" dirty="0" err="1" smtClean="0"/>
              <a:t>deep-sequencing</a:t>
            </a:r>
            <a:r>
              <a:rPr lang="es-ES" sz="1200" dirty="0" smtClean="0"/>
              <a:t> </a:t>
            </a:r>
            <a:r>
              <a:rPr lang="es-ES" sz="1200" dirty="0" err="1" smtClean="0"/>
              <a:t>analyses</a:t>
            </a:r>
            <a:r>
              <a:rPr lang="es-ES" sz="1200" dirty="0" smtClean="0"/>
              <a:t>. </a:t>
            </a:r>
            <a:r>
              <a:rPr lang="es-ES" sz="1200" dirty="0" err="1" smtClean="0"/>
              <a:t>Sequences</a:t>
            </a:r>
            <a:r>
              <a:rPr lang="es-ES" sz="1200" dirty="0" smtClean="0"/>
              <a:t> of </a:t>
            </a:r>
            <a:r>
              <a:rPr lang="es-ES" sz="1200" dirty="0" err="1" smtClean="0"/>
              <a:t>all</a:t>
            </a:r>
            <a:r>
              <a:rPr lang="es-ES" sz="1200" dirty="0" smtClean="0"/>
              <a:t> primer </a:t>
            </a:r>
            <a:r>
              <a:rPr lang="es-ES" sz="1200" dirty="0" err="1" smtClean="0"/>
              <a:t>used</a:t>
            </a:r>
            <a:r>
              <a:rPr lang="es-ES" sz="1200" dirty="0" smtClean="0"/>
              <a:t> in </a:t>
            </a:r>
            <a:r>
              <a:rPr lang="es-ES" sz="1200" dirty="0" err="1" smtClean="0"/>
              <a:t>this</a:t>
            </a:r>
            <a:r>
              <a:rPr lang="es-ES" sz="1200" dirty="0" smtClean="0"/>
              <a:t> </a:t>
            </a:r>
            <a:r>
              <a:rPr lang="es-ES" sz="1200" dirty="0" err="1" smtClean="0"/>
              <a:t>study</a:t>
            </a:r>
            <a:r>
              <a:rPr lang="es-ES" sz="1200" dirty="0" smtClean="0"/>
              <a:t> are </a:t>
            </a:r>
            <a:r>
              <a:rPr lang="es-ES" sz="1200" dirty="0" err="1" smtClean="0"/>
              <a:t>included</a:t>
            </a:r>
            <a:r>
              <a:rPr lang="es-ES" sz="1200" dirty="0" smtClean="0"/>
              <a:t> </a:t>
            </a:r>
            <a:r>
              <a:rPr lang="es-ES" sz="1200" dirty="0" err="1" smtClean="0"/>
              <a:t>below</a:t>
            </a:r>
            <a:r>
              <a:rPr lang="es-ES" sz="1200" dirty="0" smtClean="0"/>
              <a:t>.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asterik</a:t>
            </a:r>
            <a:r>
              <a:rPr lang="es-ES" sz="1200" dirty="0" smtClean="0"/>
              <a:t> </a:t>
            </a:r>
            <a:r>
              <a:rPr lang="es-ES" sz="1200" dirty="0" err="1" smtClean="0"/>
              <a:t>indicates</a:t>
            </a:r>
            <a:r>
              <a:rPr lang="es-ES" sz="1200" dirty="0" smtClean="0"/>
              <a:t> </a:t>
            </a:r>
            <a:r>
              <a:rPr lang="es-ES" sz="1200" dirty="0" err="1" smtClean="0"/>
              <a:t>primers</a:t>
            </a:r>
            <a:r>
              <a:rPr lang="es-ES" sz="1200" dirty="0" smtClean="0"/>
              <a:t> </a:t>
            </a:r>
            <a:r>
              <a:rPr lang="es-ES" sz="1200" dirty="0" err="1" smtClean="0"/>
              <a:t>that</a:t>
            </a:r>
            <a:r>
              <a:rPr lang="es-ES" sz="1200" dirty="0" smtClean="0"/>
              <a:t> </a:t>
            </a:r>
            <a:r>
              <a:rPr lang="es-ES" sz="1200" dirty="0" err="1" smtClean="0"/>
              <a:t>were</a:t>
            </a:r>
            <a:r>
              <a:rPr lang="es-ES" sz="1200" dirty="0" smtClean="0"/>
              <a:t> </a:t>
            </a:r>
            <a:r>
              <a:rPr lang="es-ES" sz="1200" dirty="0" err="1" smtClean="0"/>
              <a:t>used</a:t>
            </a:r>
            <a:r>
              <a:rPr lang="es-ES" sz="1200" dirty="0" smtClean="0"/>
              <a:t> </a:t>
            </a:r>
            <a:r>
              <a:rPr lang="es-ES" sz="1200" dirty="0" err="1" smtClean="0"/>
              <a:t>for</a:t>
            </a:r>
            <a:r>
              <a:rPr lang="es-ES" sz="1200" dirty="0" smtClean="0"/>
              <a:t> </a:t>
            </a:r>
            <a:r>
              <a:rPr lang="es-ES" sz="1200" dirty="0" err="1" smtClean="0"/>
              <a:t>Sanger</a:t>
            </a:r>
            <a:r>
              <a:rPr lang="es-ES" sz="1200" dirty="0" smtClean="0"/>
              <a:t> </a:t>
            </a:r>
            <a:r>
              <a:rPr lang="es-ES" sz="1200" dirty="0" err="1" smtClean="0"/>
              <a:t>sequencing</a:t>
            </a:r>
            <a:r>
              <a:rPr lang="es-ES" sz="1200" dirty="0" smtClean="0"/>
              <a:t> of </a:t>
            </a:r>
            <a:r>
              <a:rPr lang="es-ES" sz="1200" dirty="0" err="1" smtClean="0"/>
              <a:t>the</a:t>
            </a:r>
            <a:r>
              <a:rPr lang="es-ES" sz="1200" dirty="0"/>
              <a:t> </a:t>
            </a:r>
            <a:r>
              <a:rPr lang="es-ES" sz="1200" dirty="0" smtClean="0"/>
              <a:t>full-</a:t>
            </a:r>
            <a:r>
              <a:rPr lang="es-ES" sz="1200" dirty="0" err="1" smtClean="0"/>
              <a:t>length</a:t>
            </a:r>
            <a:r>
              <a:rPr lang="es-ES" sz="1200" dirty="0" smtClean="0"/>
              <a:t> </a:t>
            </a:r>
            <a:r>
              <a:rPr lang="es-ES" sz="1200" dirty="0" err="1" smtClean="0"/>
              <a:t>genome</a:t>
            </a:r>
            <a:r>
              <a:rPr lang="es-ES" sz="1200" dirty="0" smtClean="0"/>
              <a:t>. </a:t>
            </a:r>
            <a:endParaRPr lang="es-ES" sz="1200" dirty="0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theme/theme1.xml><?xml version="1.0" encoding="utf-8"?>
<a:theme xmlns:a="http://schemas.openxmlformats.org/drawingml/2006/main" name="Predeterminado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6</TotalTime>
  <Words>117</Words>
  <Application>Microsoft Office PowerPoint</Application>
  <PresentationFormat>Personalizado</PresentationFormat>
  <Paragraphs>64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8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10" baseType="lpstr">
      <vt:lpstr>Microsoft YaHei</vt:lpstr>
      <vt:lpstr>Arial</vt:lpstr>
      <vt:lpstr>Calibri</vt:lpstr>
      <vt:lpstr>Cambria</vt:lpstr>
      <vt:lpstr>Lucida Sans Unicode</vt:lpstr>
      <vt:lpstr>Mangal</vt:lpstr>
      <vt:lpstr>Tahoma</vt:lpstr>
      <vt:lpstr>Times New Roman</vt:lpstr>
      <vt:lpstr>Predeterminado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er</dc:creator>
  <cp:lastModifiedBy>Ruben</cp:lastModifiedBy>
  <cp:revision>14</cp:revision>
  <dcterms:created xsi:type="dcterms:W3CDTF">2014-02-21T15:16:24Z</dcterms:created>
  <dcterms:modified xsi:type="dcterms:W3CDTF">2014-09-05T13:45:47Z</dcterms:modified>
</cp:coreProperties>
</file>